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60" r:id="rId4"/>
    <p:sldId id="26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6" d="100"/>
          <a:sy n="76" d="100"/>
        </p:scale>
        <p:origin x="869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0086DA-62C4-B80F-5A13-50E8285D42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B68E555-968B-1642-F54D-140EDC54C79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1CE97A-D2D8-DAF3-B835-054E2524D4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D894B-518A-41EE-A226-19C4D984FEF3}" type="datetimeFigureOut">
              <a:rPr lang="en-US" smtClean="0"/>
              <a:t>10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08FCB9-F9F1-22BB-78EA-23D84505A0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53F5FA-A053-E3CE-52A1-1D29EC45BB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472A2-A488-42D8-BFB0-7A76EFDC2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815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58D982-75AD-966F-F804-7301EBCBB9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FC32691-8373-9E36-7388-5733F7B85C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B9F095-172C-103D-9A56-6E3CAD48CE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D894B-518A-41EE-A226-19C4D984FEF3}" type="datetimeFigureOut">
              <a:rPr lang="en-US" smtClean="0"/>
              <a:t>10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F6EA9C-6D88-C3D0-9159-C11ED238C7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247026-3060-9B6C-E927-C1D68D35C6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472A2-A488-42D8-BFB0-7A76EFDC2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543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BFF6F80-9230-4FD6-2C0A-48DF2CED5AB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F2A913-4491-4704-AE6C-86B90D732F6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1E61C3-135D-A211-DEEF-80D3D82B55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D894B-518A-41EE-A226-19C4D984FEF3}" type="datetimeFigureOut">
              <a:rPr lang="en-US" smtClean="0"/>
              <a:t>10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59F09C-6BED-826F-AFC7-9F8F5FDD5B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1AE877-87A8-3B39-DEA3-C4AFB09DF4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472A2-A488-42D8-BFB0-7A76EFDC2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4251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D938AF-C684-448E-2E64-925EDE5A6B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345E3F-5E09-7EF8-057A-3432DBF7E12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3E0478-74DE-503E-E796-FD8BC7CA8F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D894B-518A-41EE-A226-19C4D984FEF3}" type="datetimeFigureOut">
              <a:rPr lang="en-US" smtClean="0"/>
              <a:t>10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7F4488-CFAB-076B-2F5C-D5F1D55F7B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BF2BC1-583D-EF08-CAD2-4D1CCC582A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472A2-A488-42D8-BFB0-7A76EFDC2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7209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D62B88-DBD6-DF82-D1ED-A91DF33581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A70003-DE57-8FF8-B3BE-7386F4F8B8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F134CD-AF39-ADF2-6A1C-FA9C96BDD6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D894B-518A-41EE-A226-19C4D984FEF3}" type="datetimeFigureOut">
              <a:rPr lang="en-US" smtClean="0"/>
              <a:t>10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A80D27-A16D-32BA-BCCE-51F4F06B6C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AF61A1-2E46-6613-D998-179F49337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472A2-A488-42D8-BFB0-7A76EFDC2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7471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328355-13BB-1E52-A9CB-59D4F5B597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21DB5C-A3D1-B44A-5931-DF14B78BF23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1A2AE2-2CBB-D6BC-1316-702E177AA6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A0C7BB-FBF6-C991-72C2-C89A510DA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D894B-518A-41EE-A226-19C4D984FEF3}" type="datetimeFigureOut">
              <a:rPr lang="en-US" smtClean="0"/>
              <a:t>10/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39F981-17FD-63D9-A6D8-980BC347E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AA18E5-1526-8FCE-36EF-1D64131A68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472A2-A488-42D8-BFB0-7A76EFDC2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744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98C4E0-134B-89A0-611C-1BC9E4C831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A64181-2441-3259-3EC5-8E1FC94821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26E11B4-5D7B-9CBE-F7ED-9667982D2C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74BE0EC-B4F3-282B-A949-96D9521441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01266FC-FF90-8C15-D4B4-8D16D2C5AE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0A4C110-4351-88BE-4CBF-FE4CB39AB3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D894B-518A-41EE-A226-19C4D984FEF3}" type="datetimeFigureOut">
              <a:rPr lang="en-US" smtClean="0"/>
              <a:t>10/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196113A-E3B4-684F-D594-3353ED4D6B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E0EB7E9-82D8-BFB7-4E17-B3AD59999B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472A2-A488-42D8-BFB0-7A76EFDC2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1723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9D6C41-DCCB-5122-9D25-F9CA0F4FFF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784DD4A-99E4-67C1-EE28-C96E4D5058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D894B-518A-41EE-A226-19C4D984FEF3}" type="datetimeFigureOut">
              <a:rPr lang="en-US" smtClean="0"/>
              <a:t>10/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F36A27A-19BC-7A24-6D08-8EC5E571F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1FD0673-9057-2840-FE32-CAB8FE4F7E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472A2-A488-42D8-BFB0-7A76EFDC2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51914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D0AE2CC-56F3-D2E3-FE68-E2CD0D5DDD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D894B-518A-41EE-A226-19C4D984FEF3}" type="datetimeFigureOut">
              <a:rPr lang="en-US" smtClean="0"/>
              <a:t>10/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64FBC42-9D27-1837-D81F-B6B553C4F1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3B62AFA-1495-5436-8B3A-EC1BAFAEF0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472A2-A488-42D8-BFB0-7A76EFDC2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5211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71BF8C-A5FD-3B3C-65E9-EA9F1D1115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3A29AC-3CD9-DD95-959C-F0CD23FC6E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ECCF4B-8698-33DB-9055-FF5E9453C7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B9CD17-2FA9-F852-EEEF-907E4EC096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D894B-518A-41EE-A226-19C4D984FEF3}" type="datetimeFigureOut">
              <a:rPr lang="en-US" smtClean="0"/>
              <a:t>10/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46F869-A7BE-58D0-95F9-A3DC40FF9F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EA2423-2E3B-1C5A-2D5E-DCDF8D62E7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472A2-A488-42D8-BFB0-7A76EFDC2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2164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6E689B-C322-C2A8-64FA-AB72C95617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41C7E54-05E8-93AD-6A4C-D80E460C33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6A8A285-4192-2167-295D-A50C48D55D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54BFB0-5C66-2AAE-40A5-5AC644148E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D894B-518A-41EE-A226-19C4D984FEF3}" type="datetimeFigureOut">
              <a:rPr lang="en-US" smtClean="0"/>
              <a:t>10/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605E3B-3173-21D1-CC57-2B75DC354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5A71D1-A24D-0242-34BA-D7915339BB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472A2-A488-42D8-BFB0-7A76EFDC2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311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74F08FA-2B37-6365-0EEE-25BE82C461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AD7C6E-D34A-9368-6A25-AC22C0ACDF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BF05D6-F7B4-AE24-EFF7-2345C62490C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DED894B-518A-41EE-A226-19C4D984FEF3}" type="datetimeFigureOut">
              <a:rPr lang="en-US" smtClean="0"/>
              <a:t>10/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62C08D-A820-316E-1CA7-B816F2E9753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29CB0E-5569-D625-33AE-81591EFAB97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98472A2-A488-42D8-BFB0-7A76EFDC2D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7467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0F3035ED-648F-B3E0-2134-8C98B7373EC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4129604" y="1465676"/>
            <a:ext cx="3413760" cy="2560320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6398A3F-3366-8E46-F908-8BF6882C123C}"/>
              </a:ext>
            </a:extLst>
          </p:cNvPr>
          <p:cNvSpPr txBox="1"/>
          <p:nvPr/>
        </p:nvSpPr>
        <p:spPr>
          <a:xfrm>
            <a:off x="5509477" y="2607335"/>
            <a:ext cx="47568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*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FD39DB2-27C9-90B8-E2CE-E938F25232C8}"/>
              </a:ext>
            </a:extLst>
          </p:cNvPr>
          <p:cNvSpPr txBox="1"/>
          <p:nvPr/>
        </p:nvSpPr>
        <p:spPr>
          <a:xfrm>
            <a:off x="6407499" y="2607335"/>
            <a:ext cx="47568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*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BCA97EC-1632-6C0C-1EA0-F011837AE8F0}"/>
              </a:ext>
            </a:extLst>
          </p:cNvPr>
          <p:cNvSpPr txBox="1"/>
          <p:nvPr/>
        </p:nvSpPr>
        <p:spPr>
          <a:xfrm>
            <a:off x="3235569" y="4250453"/>
            <a:ext cx="51146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F-2 Transcript. Progesterone reduces IGF2 transcription in T-47D cells. P&lt;0.05 for both P4 and P4+E2 treatments.  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67586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-up of a test&#10;&#10;Description automatically generated">
            <a:extLst>
              <a:ext uri="{FF2B5EF4-FFF2-40B4-BE49-F238E27FC236}">
                <a16:creationId xmlns:a16="http://schemas.microsoft.com/office/drawing/2014/main" id="{9E3FC4BC-1CBB-160D-78E0-93ED53ABB74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770" t="43737" r="15056" b="44706"/>
          <a:stretch/>
        </p:blipFill>
        <p:spPr>
          <a:xfrm>
            <a:off x="1825532" y="1815980"/>
            <a:ext cx="3657600" cy="440496"/>
          </a:xfrm>
          <a:prstGeom prst="rect">
            <a:avLst/>
          </a:prstGeom>
        </p:spPr>
      </p:pic>
      <p:pic>
        <p:nvPicPr>
          <p:cNvPr id="5" name="Picture 4" descr="A blurry image of a bar&#10;&#10;Description automatically generated">
            <a:extLst>
              <a:ext uri="{FF2B5EF4-FFF2-40B4-BE49-F238E27FC236}">
                <a16:creationId xmlns:a16="http://schemas.microsoft.com/office/drawing/2014/main" id="{8007DF4B-5ABC-E405-2977-DB1B35B4995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9114" t="50182" r="19449" b="40698"/>
          <a:stretch/>
        </p:blipFill>
        <p:spPr>
          <a:xfrm>
            <a:off x="1877299" y="1400148"/>
            <a:ext cx="3657600" cy="38007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DCA3941-7A58-A9FD-7860-C8F7876FE317}"/>
              </a:ext>
            </a:extLst>
          </p:cNvPr>
          <p:cNvSpPr txBox="1"/>
          <p:nvPr/>
        </p:nvSpPr>
        <p:spPr>
          <a:xfrm>
            <a:off x="5450137" y="1301815"/>
            <a:ext cx="11719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Phospho-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4BB5867-BE17-9F0B-794B-C04E88121234}"/>
              </a:ext>
            </a:extLst>
          </p:cNvPr>
          <p:cNvSpPr txBox="1"/>
          <p:nvPr/>
        </p:nvSpPr>
        <p:spPr>
          <a:xfrm>
            <a:off x="5480477" y="1759229"/>
            <a:ext cx="9169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PR-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683E7D9-107B-0223-0D7A-2B4B6EC67BC9}"/>
              </a:ext>
            </a:extLst>
          </p:cNvPr>
          <p:cNvSpPr txBox="1"/>
          <p:nvPr/>
        </p:nvSpPr>
        <p:spPr>
          <a:xfrm>
            <a:off x="5455921" y="1534923"/>
            <a:ext cx="12563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Phospho-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1DC0082-D5E2-2509-EBED-447A0B0409FE}"/>
              </a:ext>
            </a:extLst>
          </p:cNvPr>
          <p:cNvSpPr txBox="1"/>
          <p:nvPr/>
        </p:nvSpPr>
        <p:spPr>
          <a:xfrm>
            <a:off x="5480477" y="1981486"/>
            <a:ext cx="9169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PR-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AE51012-D4FE-78BE-7552-A0E46891E6CD}"/>
              </a:ext>
            </a:extLst>
          </p:cNvPr>
          <p:cNvSpPr txBox="1">
            <a:spLocks noChangeAspect="1"/>
          </p:cNvSpPr>
          <p:nvPr/>
        </p:nvSpPr>
        <p:spPr>
          <a:xfrm>
            <a:off x="1881880" y="1132940"/>
            <a:ext cx="501033" cy="274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N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D30882F-993E-97AB-0736-6E0B83ED454D}"/>
              </a:ext>
            </a:extLst>
          </p:cNvPr>
          <p:cNvSpPr txBox="1">
            <a:spLocks noChangeAspect="1"/>
          </p:cNvSpPr>
          <p:nvPr/>
        </p:nvSpPr>
        <p:spPr>
          <a:xfrm>
            <a:off x="2369575" y="1129554"/>
            <a:ext cx="401504" cy="274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652CC20-A9BC-BC52-47E2-719EA7EAFDEA}"/>
              </a:ext>
            </a:extLst>
          </p:cNvPr>
          <p:cNvSpPr txBox="1">
            <a:spLocks noChangeAspect="1"/>
          </p:cNvSpPr>
          <p:nvPr/>
        </p:nvSpPr>
        <p:spPr>
          <a:xfrm>
            <a:off x="2702977" y="1129554"/>
            <a:ext cx="502607" cy="274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253C43A-D7EE-7B28-0BC0-5EB226B0AAE2}"/>
              </a:ext>
            </a:extLst>
          </p:cNvPr>
          <p:cNvSpPr txBox="1">
            <a:spLocks noChangeAspect="1"/>
          </p:cNvSpPr>
          <p:nvPr/>
        </p:nvSpPr>
        <p:spPr>
          <a:xfrm>
            <a:off x="3028634" y="1136485"/>
            <a:ext cx="620181" cy="274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N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94FE1F8-A010-D6FB-68EE-D1E57D21763A}"/>
              </a:ext>
            </a:extLst>
          </p:cNvPr>
          <p:cNvSpPr txBox="1">
            <a:spLocks noChangeAspect="1"/>
          </p:cNvSpPr>
          <p:nvPr/>
        </p:nvSpPr>
        <p:spPr>
          <a:xfrm>
            <a:off x="3545163" y="1127495"/>
            <a:ext cx="337916" cy="274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B1B148B-D661-06F6-3EB1-7FC4CEDE7390}"/>
              </a:ext>
            </a:extLst>
          </p:cNvPr>
          <p:cNvSpPr txBox="1">
            <a:spLocks noChangeAspect="1"/>
          </p:cNvSpPr>
          <p:nvPr/>
        </p:nvSpPr>
        <p:spPr>
          <a:xfrm>
            <a:off x="4168711" y="1125828"/>
            <a:ext cx="612028" cy="274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N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74403F8-8631-76BC-A100-EEC74BE52EF6}"/>
              </a:ext>
            </a:extLst>
          </p:cNvPr>
          <p:cNvSpPr txBox="1">
            <a:spLocks noChangeAspect="1"/>
          </p:cNvSpPr>
          <p:nvPr/>
        </p:nvSpPr>
        <p:spPr>
          <a:xfrm>
            <a:off x="3875861" y="1125828"/>
            <a:ext cx="443053" cy="274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E6C06B9-6ACB-743F-C412-0F40B9BE8444}"/>
              </a:ext>
            </a:extLst>
          </p:cNvPr>
          <p:cNvSpPr txBox="1">
            <a:spLocks noChangeAspect="1"/>
          </p:cNvSpPr>
          <p:nvPr/>
        </p:nvSpPr>
        <p:spPr>
          <a:xfrm>
            <a:off x="5028852" y="1132940"/>
            <a:ext cx="451626" cy="274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CA4557F-DD51-06F6-9ECD-DF78AA788F3B}"/>
              </a:ext>
            </a:extLst>
          </p:cNvPr>
          <p:cNvSpPr txBox="1">
            <a:spLocks noChangeAspect="1"/>
          </p:cNvSpPr>
          <p:nvPr/>
        </p:nvSpPr>
        <p:spPr>
          <a:xfrm>
            <a:off x="4632834" y="1134607"/>
            <a:ext cx="451626" cy="274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6BBFAE7-9A0B-5174-5A27-6DDCCD6D74C2}"/>
              </a:ext>
            </a:extLst>
          </p:cNvPr>
          <p:cNvSpPr txBox="1">
            <a:spLocks noChangeAspect="1"/>
          </p:cNvSpPr>
          <p:nvPr/>
        </p:nvSpPr>
        <p:spPr>
          <a:xfrm>
            <a:off x="2326649" y="843415"/>
            <a:ext cx="5239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V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42496CF-C6E0-0C36-0E36-C81471E25F9C}"/>
              </a:ext>
            </a:extLst>
          </p:cNvPr>
          <p:cNvSpPr txBox="1">
            <a:spLocks noChangeAspect="1"/>
          </p:cNvSpPr>
          <p:nvPr/>
        </p:nvSpPr>
        <p:spPr>
          <a:xfrm>
            <a:off x="4596660" y="843659"/>
            <a:ext cx="5239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P+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DA61743-BAE1-B1C6-8B62-88B7A0BC32A7}"/>
              </a:ext>
            </a:extLst>
          </p:cNvPr>
          <p:cNvSpPr txBox="1">
            <a:spLocks noChangeAspect="1"/>
          </p:cNvSpPr>
          <p:nvPr/>
        </p:nvSpPr>
        <p:spPr>
          <a:xfrm>
            <a:off x="3461475" y="847995"/>
            <a:ext cx="5239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P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B7F34C9-63F6-EB56-1EB7-8747BC1B3B93}"/>
              </a:ext>
            </a:extLst>
          </p:cNvPr>
          <p:cNvSpPr txBox="1"/>
          <p:nvPr/>
        </p:nvSpPr>
        <p:spPr>
          <a:xfrm>
            <a:off x="5534899" y="3397273"/>
            <a:ext cx="493394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2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immunoblot showing relative PR phosphorylation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phosphorylation of  PR-A. IGFBP-6 knockdown produced no significant changes in relative phosphorylation at S130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phosphorylation of PR-B. Knockdown of IGFBP-6 produced no significant changes in relative phosphorylation at S294. 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42A7DAC6-8F96-0367-E89E-84FB7E6FA10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77021" y="2665196"/>
            <a:ext cx="3413760" cy="256032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DDC663A6-1EB7-212F-28EB-DF82048418C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01220" y="288525"/>
            <a:ext cx="3161042" cy="2560320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1067ADED-2055-54C6-D36E-DCC869F9B8AF}"/>
              </a:ext>
            </a:extLst>
          </p:cNvPr>
          <p:cNvSpPr txBox="1"/>
          <p:nvPr/>
        </p:nvSpPr>
        <p:spPr>
          <a:xfrm>
            <a:off x="1321676" y="555874"/>
            <a:ext cx="460942" cy="3695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A8270A0-A0FF-64C6-A28D-B03AE78E6469}"/>
              </a:ext>
            </a:extLst>
          </p:cNvPr>
          <p:cNvSpPr txBox="1"/>
          <p:nvPr/>
        </p:nvSpPr>
        <p:spPr>
          <a:xfrm>
            <a:off x="6317057" y="478487"/>
            <a:ext cx="401940" cy="3695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9644CD9-7E4B-DC04-8F82-3FE1C2DA5909}"/>
              </a:ext>
            </a:extLst>
          </p:cNvPr>
          <p:cNvSpPr txBox="1"/>
          <p:nvPr/>
        </p:nvSpPr>
        <p:spPr>
          <a:xfrm>
            <a:off x="1303609" y="2480530"/>
            <a:ext cx="4970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C)</a:t>
            </a:r>
          </a:p>
        </p:txBody>
      </p:sp>
    </p:spTree>
    <p:extLst>
      <p:ext uri="{BB962C8B-B14F-4D97-AF65-F5344CB8AC3E}">
        <p14:creationId xmlns:p14="http://schemas.microsoft.com/office/powerpoint/2010/main" val="33878686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66363CA-71CD-1369-7640-37CF367AE76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r="8656"/>
          <a:stretch/>
        </p:blipFill>
        <p:spPr>
          <a:xfrm>
            <a:off x="2300026" y="986601"/>
            <a:ext cx="3437583" cy="282250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6384EE6-1E43-7298-0373-D952EF91156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9445" t="45536" r="18645" b="42966"/>
          <a:stretch/>
        </p:blipFill>
        <p:spPr>
          <a:xfrm>
            <a:off x="6254471" y="1897949"/>
            <a:ext cx="4200660" cy="545389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D21160B1-E813-60AC-DDFA-FC8E93D5AF59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2181" t="31040" r="15910" b="54954"/>
          <a:stretch/>
        </p:blipFill>
        <p:spPr>
          <a:xfrm>
            <a:off x="6254471" y="2370222"/>
            <a:ext cx="4200657" cy="66438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4843E85C-B130-E07B-ED0F-25C6C1D93B4C}"/>
              </a:ext>
            </a:extLst>
          </p:cNvPr>
          <p:cNvSpPr txBox="1">
            <a:spLocks noChangeAspect="1"/>
          </p:cNvSpPr>
          <p:nvPr/>
        </p:nvSpPr>
        <p:spPr>
          <a:xfrm>
            <a:off x="6299475" y="1527854"/>
            <a:ext cx="501033" cy="274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V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9468564-3675-15AB-7295-93B0941ACA4A}"/>
              </a:ext>
            </a:extLst>
          </p:cNvPr>
          <p:cNvSpPr txBox="1">
            <a:spLocks noChangeAspect="1"/>
          </p:cNvSpPr>
          <p:nvPr/>
        </p:nvSpPr>
        <p:spPr>
          <a:xfrm>
            <a:off x="6762170" y="1441588"/>
            <a:ext cx="6324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0nM RU486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17494CE-124B-EFF9-B233-FB7AC9BC30C8}"/>
              </a:ext>
            </a:extLst>
          </p:cNvPr>
          <p:cNvSpPr txBox="1">
            <a:spLocks noChangeAspect="1"/>
          </p:cNvSpPr>
          <p:nvPr/>
        </p:nvSpPr>
        <p:spPr>
          <a:xfrm>
            <a:off x="7766024" y="1425675"/>
            <a:ext cx="6413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2.5nM RU486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EE284C3-8B61-B7E2-B5A2-F4EF074F2A32}"/>
              </a:ext>
            </a:extLst>
          </p:cNvPr>
          <p:cNvSpPr txBox="1">
            <a:spLocks noChangeAspect="1"/>
          </p:cNvSpPr>
          <p:nvPr/>
        </p:nvSpPr>
        <p:spPr>
          <a:xfrm>
            <a:off x="7269868" y="1425674"/>
            <a:ext cx="6413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1nM RU486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4610693-BE23-4D76-7062-7B42D5FF0ADE}"/>
              </a:ext>
            </a:extLst>
          </p:cNvPr>
          <p:cNvSpPr txBox="1">
            <a:spLocks noChangeAspect="1"/>
          </p:cNvSpPr>
          <p:nvPr/>
        </p:nvSpPr>
        <p:spPr>
          <a:xfrm>
            <a:off x="8266116" y="1434182"/>
            <a:ext cx="6413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10nM RU486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ACD8A3C-036A-DB9E-83DA-0AF2746F4290}"/>
              </a:ext>
            </a:extLst>
          </p:cNvPr>
          <p:cNvSpPr txBox="1">
            <a:spLocks noChangeAspect="1"/>
          </p:cNvSpPr>
          <p:nvPr/>
        </p:nvSpPr>
        <p:spPr>
          <a:xfrm>
            <a:off x="8810876" y="1425676"/>
            <a:ext cx="6413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25nM RU486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8011961-16E3-4A63-3FE0-7E9F66336A48}"/>
              </a:ext>
            </a:extLst>
          </p:cNvPr>
          <p:cNvSpPr txBox="1">
            <a:spLocks noChangeAspect="1"/>
          </p:cNvSpPr>
          <p:nvPr/>
        </p:nvSpPr>
        <p:spPr>
          <a:xfrm>
            <a:off x="9811060" y="1436284"/>
            <a:ext cx="6413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250nM RU486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2EC33D1-5E4B-1CCD-638B-EDF2C69B6AD6}"/>
              </a:ext>
            </a:extLst>
          </p:cNvPr>
          <p:cNvSpPr txBox="1">
            <a:spLocks noChangeAspect="1"/>
          </p:cNvSpPr>
          <p:nvPr/>
        </p:nvSpPr>
        <p:spPr>
          <a:xfrm>
            <a:off x="9290445" y="1436284"/>
            <a:ext cx="6413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100nM RU486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2E17000-F62C-8669-FC54-26B20E3ECCFE}"/>
              </a:ext>
            </a:extLst>
          </p:cNvPr>
          <p:cNvSpPr txBox="1">
            <a:spLocks noChangeAspect="1"/>
          </p:cNvSpPr>
          <p:nvPr/>
        </p:nvSpPr>
        <p:spPr>
          <a:xfrm>
            <a:off x="10452400" y="2032143"/>
            <a:ext cx="733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IGFBP-6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DF7128F-37FB-7EF5-329D-EE4268E63840}"/>
              </a:ext>
            </a:extLst>
          </p:cNvPr>
          <p:cNvSpPr txBox="1">
            <a:spLocks noChangeAspect="1"/>
          </p:cNvSpPr>
          <p:nvPr/>
        </p:nvSpPr>
        <p:spPr>
          <a:xfrm>
            <a:off x="10452400" y="2539113"/>
            <a:ext cx="733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β-Acti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6C1C633-01F6-0000-A1DC-C520F34D7116}"/>
              </a:ext>
            </a:extLst>
          </p:cNvPr>
          <p:cNvSpPr txBox="1"/>
          <p:nvPr/>
        </p:nvSpPr>
        <p:spPr>
          <a:xfrm>
            <a:off x="1738160" y="801847"/>
            <a:ext cx="460942" cy="3695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7DDD65C-9D14-8C21-8BDB-699B0E1B4530}"/>
              </a:ext>
            </a:extLst>
          </p:cNvPr>
          <p:cNvSpPr txBox="1"/>
          <p:nvPr/>
        </p:nvSpPr>
        <p:spPr>
          <a:xfrm>
            <a:off x="5838533" y="801847"/>
            <a:ext cx="460942" cy="3695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B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46E873E-F9FE-DD1F-2CDE-18B487561DDB}"/>
              </a:ext>
            </a:extLst>
          </p:cNvPr>
          <p:cNvSpPr txBox="1"/>
          <p:nvPr/>
        </p:nvSpPr>
        <p:spPr>
          <a:xfrm>
            <a:off x="6149397" y="3429000"/>
            <a:ext cx="51146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hibition of IGFBP-6 induction by RU486. All treatments except the vehicle contain 50nM P4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Western Blot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23753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182C276-D702-395E-4A4B-8F0E6E4EF3B0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r="12876"/>
          <a:stretch/>
        </p:blipFill>
        <p:spPr>
          <a:xfrm>
            <a:off x="2681864" y="788293"/>
            <a:ext cx="2974205" cy="256032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C322D39-B99A-8B4E-7221-2B4C653290F4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9259"/>
          <a:stretch/>
        </p:blipFill>
        <p:spPr>
          <a:xfrm>
            <a:off x="2681864" y="3429000"/>
            <a:ext cx="3097679" cy="256032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6CBB1AF-88BE-7556-DB34-BE31FE702504}"/>
              </a:ext>
            </a:extLst>
          </p:cNvPr>
          <p:cNvSpPr txBox="1"/>
          <p:nvPr/>
        </p:nvSpPr>
        <p:spPr>
          <a:xfrm>
            <a:off x="3538694" y="5963419"/>
            <a:ext cx="597144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Intracellular IGFBP-6 inductio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Western Blot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Intracellular IGFBP-6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Extracellular IGFBP-6 induction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Western Blot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Extracellular IGFBP-6. 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BF312F1-19D0-4B26-6623-9DAE3EB73766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4574" t="50000" r="36604" b="38761"/>
          <a:stretch/>
        </p:blipFill>
        <p:spPr>
          <a:xfrm>
            <a:off x="6335486" y="1606789"/>
            <a:ext cx="2280975" cy="46166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109F5C4-D7A8-87EB-A3B0-A651E0053E5C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29705" t="50000" r="31473" b="38761"/>
          <a:stretch/>
        </p:blipFill>
        <p:spPr>
          <a:xfrm>
            <a:off x="6335486" y="2068453"/>
            <a:ext cx="2280975" cy="46166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14D7D060-6200-8A4A-4463-C5787C44BEE6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26969" t="42111" r="27710" b="46650"/>
          <a:stretch/>
        </p:blipFill>
        <p:spPr>
          <a:xfrm>
            <a:off x="6260123" y="3708904"/>
            <a:ext cx="2662813" cy="461666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ACD91AFE-E04F-DB80-32F8-E57B0AE9DE7E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34323" t="22540" r="20357" b="60645"/>
          <a:stretch/>
        </p:blipFill>
        <p:spPr>
          <a:xfrm>
            <a:off x="6260122" y="4170569"/>
            <a:ext cx="2662814" cy="69071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E496B07F-B628-5114-45E6-2C711626FD5B}"/>
              </a:ext>
            </a:extLst>
          </p:cNvPr>
          <p:cNvSpPr txBox="1"/>
          <p:nvPr/>
        </p:nvSpPr>
        <p:spPr>
          <a:xfrm>
            <a:off x="1738160" y="801847"/>
            <a:ext cx="460942" cy="3695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D4D94D5-28BF-39CE-A1AB-04954733118C}"/>
              </a:ext>
            </a:extLst>
          </p:cNvPr>
          <p:cNvSpPr txBox="1"/>
          <p:nvPr/>
        </p:nvSpPr>
        <p:spPr>
          <a:xfrm>
            <a:off x="5838533" y="801847"/>
            <a:ext cx="460942" cy="3695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B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178A0D6-B1AD-8D9C-4A60-BB73DB1B3ADD}"/>
              </a:ext>
            </a:extLst>
          </p:cNvPr>
          <p:cNvSpPr txBox="1"/>
          <p:nvPr/>
        </p:nvSpPr>
        <p:spPr>
          <a:xfrm>
            <a:off x="1738160" y="3383744"/>
            <a:ext cx="460942" cy="3695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C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323B407-D6DD-FCAA-1EF2-0328C8DBD9F8}"/>
              </a:ext>
            </a:extLst>
          </p:cNvPr>
          <p:cNvSpPr txBox="1"/>
          <p:nvPr/>
        </p:nvSpPr>
        <p:spPr>
          <a:xfrm>
            <a:off x="5838533" y="3383744"/>
            <a:ext cx="460942" cy="3695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D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7F9141F-D399-2482-A316-A70E00561718}"/>
              </a:ext>
            </a:extLst>
          </p:cNvPr>
          <p:cNvSpPr txBox="1">
            <a:spLocks noChangeAspect="1"/>
          </p:cNvSpPr>
          <p:nvPr/>
        </p:nvSpPr>
        <p:spPr>
          <a:xfrm>
            <a:off x="6335486" y="1307049"/>
            <a:ext cx="501033" cy="274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V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7FE8855-7399-0042-C971-F24DBFDEB738}"/>
              </a:ext>
            </a:extLst>
          </p:cNvPr>
          <p:cNvSpPr txBox="1">
            <a:spLocks noChangeAspect="1"/>
          </p:cNvSpPr>
          <p:nvPr/>
        </p:nvSpPr>
        <p:spPr>
          <a:xfrm>
            <a:off x="6749143" y="1305710"/>
            <a:ext cx="5861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25nM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DE53B63-0552-4E66-2608-B00AF264F927}"/>
              </a:ext>
            </a:extLst>
          </p:cNvPr>
          <p:cNvSpPr txBox="1">
            <a:spLocks noChangeAspect="1"/>
          </p:cNvSpPr>
          <p:nvPr/>
        </p:nvSpPr>
        <p:spPr>
          <a:xfrm>
            <a:off x="7162800" y="1304370"/>
            <a:ext cx="5861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50nM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B86BA64-5554-8E4D-1190-EE6D89C5ADFA}"/>
              </a:ext>
            </a:extLst>
          </p:cNvPr>
          <p:cNvSpPr txBox="1">
            <a:spLocks noChangeAspect="1"/>
          </p:cNvSpPr>
          <p:nvPr/>
        </p:nvSpPr>
        <p:spPr>
          <a:xfrm>
            <a:off x="7593203" y="1304370"/>
            <a:ext cx="6564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100nM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2B00A85-2E20-2ADF-2419-572C12AFBBFC}"/>
              </a:ext>
            </a:extLst>
          </p:cNvPr>
          <p:cNvSpPr txBox="1">
            <a:spLocks noChangeAspect="1"/>
          </p:cNvSpPr>
          <p:nvPr/>
        </p:nvSpPr>
        <p:spPr>
          <a:xfrm>
            <a:off x="8072174" y="1304369"/>
            <a:ext cx="6564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200nM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EB1B80C-3171-A04A-1D9F-E7F4F69039A4}"/>
              </a:ext>
            </a:extLst>
          </p:cNvPr>
          <p:cNvSpPr txBox="1">
            <a:spLocks noChangeAspect="1"/>
          </p:cNvSpPr>
          <p:nvPr/>
        </p:nvSpPr>
        <p:spPr>
          <a:xfrm>
            <a:off x="6720672" y="3447043"/>
            <a:ext cx="501033" cy="274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V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E5970A3-7C07-375A-DE37-B522638C389B}"/>
              </a:ext>
            </a:extLst>
          </p:cNvPr>
          <p:cNvSpPr txBox="1">
            <a:spLocks noChangeAspect="1"/>
          </p:cNvSpPr>
          <p:nvPr/>
        </p:nvSpPr>
        <p:spPr>
          <a:xfrm>
            <a:off x="7141175" y="3291587"/>
            <a:ext cx="4655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25</a:t>
            </a:r>
          </a:p>
          <a:p>
            <a:pPr algn="ctr"/>
            <a:r>
              <a:rPr lang="en-US" sz="1200" dirty="0" err="1"/>
              <a:t>nM</a:t>
            </a:r>
            <a:endParaRPr lang="en-US" sz="12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0EEFA14-8A23-259D-DA8F-B65673690C03}"/>
              </a:ext>
            </a:extLst>
          </p:cNvPr>
          <p:cNvSpPr txBox="1">
            <a:spLocks noChangeAspect="1"/>
          </p:cNvSpPr>
          <p:nvPr/>
        </p:nvSpPr>
        <p:spPr>
          <a:xfrm>
            <a:off x="7566921" y="3289364"/>
            <a:ext cx="4655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50</a:t>
            </a:r>
          </a:p>
          <a:p>
            <a:pPr algn="ctr"/>
            <a:r>
              <a:rPr lang="en-US" sz="1200" dirty="0" err="1"/>
              <a:t>nM</a:t>
            </a:r>
            <a:endParaRPr lang="en-US" sz="12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C54F311-EC2D-3CFC-2F91-0634F2C925E3}"/>
              </a:ext>
            </a:extLst>
          </p:cNvPr>
          <p:cNvSpPr txBox="1">
            <a:spLocks noChangeAspect="1"/>
          </p:cNvSpPr>
          <p:nvPr/>
        </p:nvSpPr>
        <p:spPr>
          <a:xfrm>
            <a:off x="8012141" y="3289364"/>
            <a:ext cx="4655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100</a:t>
            </a:r>
          </a:p>
          <a:p>
            <a:pPr algn="ctr"/>
            <a:r>
              <a:rPr lang="en-US" sz="1200" dirty="0" err="1"/>
              <a:t>nM</a:t>
            </a:r>
            <a:endParaRPr lang="en-US" sz="12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9FF3DD8-5EDE-699F-776C-7673F864D931}"/>
              </a:ext>
            </a:extLst>
          </p:cNvPr>
          <p:cNvSpPr txBox="1">
            <a:spLocks noChangeAspect="1"/>
          </p:cNvSpPr>
          <p:nvPr/>
        </p:nvSpPr>
        <p:spPr>
          <a:xfrm>
            <a:off x="8437261" y="3289364"/>
            <a:ext cx="4655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200</a:t>
            </a:r>
          </a:p>
          <a:p>
            <a:pPr algn="ctr"/>
            <a:r>
              <a:rPr lang="en-US" sz="1200" dirty="0" err="1"/>
              <a:t>nM</a:t>
            </a:r>
            <a:endParaRPr lang="en-US" sz="12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CD17C35-F1D6-BF25-AF20-7C3F06B7ADA6}"/>
              </a:ext>
            </a:extLst>
          </p:cNvPr>
          <p:cNvSpPr txBox="1">
            <a:spLocks noChangeAspect="1"/>
          </p:cNvSpPr>
          <p:nvPr/>
        </p:nvSpPr>
        <p:spPr>
          <a:xfrm>
            <a:off x="6241131" y="3447042"/>
            <a:ext cx="5953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edia</a:t>
            </a:r>
          </a:p>
        </p:txBody>
      </p:sp>
    </p:spTree>
    <p:extLst>
      <p:ext uri="{BB962C8B-B14F-4D97-AF65-F5344CB8AC3E}">
        <p14:creationId xmlns:p14="http://schemas.microsoft.com/office/powerpoint/2010/main" val="30451963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704</TotalTime>
  <Words>211</Words>
  <Application>Microsoft Office PowerPoint</Application>
  <PresentationFormat>Widescreen</PresentationFormat>
  <Paragraphs>5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cisco Lariz</dc:creator>
  <cp:lastModifiedBy>Francisco Lariz</cp:lastModifiedBy>
  <cp:revision>41</cp:revision>
  <dcterms:created xsi:type="dcterms:W3CDTF">2024-06-03T20:22:04Z</dcterms:created>
  <dcterms:modified xsi:type="dcterms:W3CDTF">2024-10-02T09:44:22Z</dcterms:modified>
</cp:coreProperties>
</file>